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9" r:id="rId2"/>
    <p:sldId id="260" r:id="rId3"/>
    <p:sldId id="261" r:id="rId4"/>
    <p:sldId id="262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A5DAC37-D6B2-4716-AE0D-A3B2A8925BB0}" v="31" dt="2025-06-02T08:03:38.5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86"/>
    <p:restoredTop sz="94694"/>
  </p:normalViewPr>
  <p:slideViewPr>
    <p:cSldViewPr snapToGrid="0">
      <p:cViewPr varScale="1">
        <p:scale>
          <a:sx n="106" d="100"/>
          <a:sy n="106" d="100"/>
        </p:scale>
        <p:origin x="144" y="4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hishek Kumar" userId="cdeadaa3-b55e-4373-8448-bfeb5386a732" providerId="ADAL" clId="{9A5DAC37-D6B2-4716-AE0D-A3B2A8925BB0}"/>
    <pc:docChg chg="modSld">
      <pc:chgData name="Abhishek Kumar" userId="cdeadaa3-b55e-4373-8448-bfeb5386a732" providerId="ADAL" clId="{9A5DAC37-D6B2-4716-AE0D-A3B2A8925BB0}" dt="2025-06-02T08:03:38.559" v="24" actId="20577"/>
      <pc:docMkLst>
        <pc:docMk/>
      </pc:docMkLst>
      <pc:sldChg chg="modSp">
        <pc:chgData name="Abhishek Kumar" userId="cdeadaa3-b55e-4373-8448-bfeb5386a732" providerId="ADAL" clId="{9A5DAC37-D6B2-4716-AE0D-A3B2A8925BB0}" dt="2025-06-02T08:03:38.559" v="24" actId="20577"/>
        <pc:sldMkLst>
          <pc:docMk/>
          <pc:sldMk cId="3853289890" sldId="262"/>
        </pc:sldMkLst>
        <pc:graphicFrameChg chg="mod">
          <ac:chgData name="Abhishek Kumar" userId="cdeadaa3-b55e-4373-8448-bfeb5386a732" providerId="ADAL" clId="{9A5DAC37-D6B2-4716-AE0D-A3B2A8925BB0}" dt="2025-06-02T08:03:30.064" v="15" actId="20577"/>
          <ac:graphicFrameMkLst>
            <pc:docMk/>
            <pc:sldMk cId="3853289890" sldId="262"/>
            <ac:graphicFrameMk id="2" creationId="{EBB2D890-792B-A925-FAA4-FB2E005B80BC}"/>
          </ac:graphicFrameMkLst>
        </pc:graphicFrameChg>
        <pc:graphicFrameChg chg="mod">
          <ac:chgData name="Abhishek Kumar" userId="cdeadaa3-b55e-4373-8448-bfeb5386a732" providerId="ADAL" clId="{9A5DAC37-D6B2-4716-AE0D-A3B2A8925BB0}" dt="2025-06-02T08:03:38.559" v="24" actId="20577"/>
          <ac:graphicFrameMkLst>
            <pc:docMk/>
            <pc:sldMk cId="3853289890" sldId="262"/>
            <ac:graphicFrameMk id="4" creationId="{067AD267-AF97-5F23-4DE8-492520415027}"/>
          </ac:graphicFrameMkLst>
        </pc:graphicFrameChg>
      </pc:sldChg>
    </pc:docChg>
  </pc:docChgLst>
  <pc:docChgLst>
    <pc:chgData name="Abhishek Kumar" userId="cdeadaa3-b55e-4373-8448-bfeb5386a732" providerId="ADAL" clId="{3310C73A-675A-4853-BECC-5731EC7B0408}"/>
    <pc:docChg chg="undo custSel addSld delSld modSld delMainMaster">
      <pc:chgData name="Abhishek Kumar" userId="cdeadaa3-b55e-4373-8448-bfeb5386a732" providerId="ADAL" clId="{3310C73A-675A-4853-BECC-5731EC7B0408}" dt="2024-11-05T09:32:05.952" v="254" actId="1076"/>
      <pc:docMkLst>
        <pc:docMk/>
      </pc:docMkLst>
      <pc:sldChg chg="add del">
        <pc:chgData name="Abhishek Kumar" userId="cdeadaa3-b55e-4373-8448-bfeb5386a732" providerId="ADAL" clId="{3310C73A-675A-4853-BECC-5731EC7B0408}" dt="2024-10-31T09:38:39.370" v="58"/>
        <pc:sldMkLst>
          <pc:docMk/>
          <pc:sldMk cId="2023911423" sldId="256"/>
        </pc:sldMkLst>
      </pc:sldChg>
      <pc:sldChg chg="del">
        <pc:chgData name="Abhishek Kumar" userId="cdeadaa3-b55e-4373-8448-bfeb5386a732" providerId="ADAL" clId="{3310C73A-675A-4853-BECC-5731EC7B0408}" dt="2024-09-30T09:11:17.240" v="27" actId="47"/>
        <pc:sldMkLst>
          <pc:docMk/>
          <pc:sldMk cId="4245158138" sldId="257"/>
        </pc:sldMkLst>
      </pc:sldChg>
      <pc:sldChg chg="del">
        <pc:chgData name="Abhishek Kumar" userId="cdeadaa3-b55e-4373-8448-bfeb5386a732" providerId="ADAL" clId="{3310C73A-675A-4853-BECC-5731EC7B0408}" dt="2024-09-30T09:11:16.127" v="26" actId="47"/>
        <pc:sldMkLst>
          <pc:docMk/>
          <pc:sldMk cId="688813374" sldId="258"/>
        </pc:sldMkLst>
      </pc:sldChg>
      <pc:sldChg chg="addSp delSp modSp new mod setBg">
        <pc:chgData name="Abhishek Kumar" userId="cdeadaa3-b55e-4373-8448-bfeb5386a732" providerId="ADAL" clId="{3310C73A-675A-4853-BECC-5731EC7B0408}" dt="2024-11-05T09:25:53.369" v="157"/>
        <pc:sldMkLst>
          <pc:docMk/>
          <pc:sldMk cId="3847580501" sldId="259"/>
        </pc:sldMkLst>
      </pc:sldChg>
      <pc:sldChg chg="addSp delSp modSp new mod setBg">
        <pc:chgData name="Abhishek Kumar" userId="cdeadaa3-b55e-4373-8448-bfeb5386a732" providerId="ADAL" clId="{3310C73A-675A-4853-BECC-5731EC7B0408}" dt="2024-11-05T09:25:52.482" v="156"/>
        <pc:sldMkLst>
          <pc:docMk/>
          <pc:sldMk cId="3065658699" sldId="260"/>
        </pc:sldMkLst>
      </pc:sldChg>
      <pc:sldChg chg="addSp delSp modSp new mod setBg">
        <pc:chgData name="Abhishek Kumar" userId="cdeadaa3-b55e-4373-8448-bfeb5386a732" providerId="ADAL" clId="{3310C73A-675A-4853-BECC-5731EC7B0408}" dt="2024-11-05T09:25:51.510" v="154"/>
        <pc:sldMkLst>
          <pc:docMk/>
          <pc:sldMk cId="3429698511" sldId="261"/>
        </pc:sldMkLst>
      </pc:sldChg>
      <pc:sldChg chg="addSp delSp modSp new del mod">
        <pc:chgData name="Abhishek Kumar" userId="cdeadaa3-b55e-4373-8448-bfeb5386a732" providerId="ADAL" clId="{3310C73A-675A-4853-BECC-5731EC7B0408}" dt="2024-09-30T10:01:29.557" v="28" actId="47"/>
        <pc:sldMkLst>
          <pc:docMk/>
          <pc:sldMk cId="3974933372" sldId="261"/>
        </pc:sldMkLst>
      </pc:sldChg>
      <pc:sldChg chg="addSp delSp modSp new mod">
        <pc:chgData name="Abhishek Kumar" userId="cdeadaa3-b55e-4373-8448-bfeb5386a732" providerId="ADAL" clId="{3310C73A-675A-4853-BECC-5731EC7B0408}" dt="2024-11-05T09:32:05.952" v="254" actId="1076"/>
        <pc:sldMkLst>
          <pc:docMk/>
          <pc:sldMk cId="3853289890" sldId="262"/>
        </pc:sldMkLst>
      </pc:sldChg>
      <pc:sldChg chg="del">
        <pc:chgData name="Abhishek Kumar" userId="cdeadaa3-b55e-4373-8448-bfeb5386a732" providerId="ADAL" clId="{3310C73A-675A-4853-BECC-5731EC7B0408}" dt="2024-10-15T12:28:22.470" v="53" actId="47"/>
        <pc:sldMkLst>
          <pc:docMk/>
          <pc:sldMk cId="2625443509" sldId="1066"/>
        </pc:sldMkLst>
      </pc:sldChg>
      <pc:sldMasterChg chg="del delSldLayout">
        <pc:chgData name="Abhishek Kumar" userId="cdeadaa3-b55e-4373-8448-bfeb5386a732" providerId="ADAL" clId="{3310C73A-675A-4853-BECC-5731EC7B0408}" dt="2024-10-15T12:28:22.470" v="53" actId="47"/>
        <pc:sldMasterMkLst>
          <pc:docMk/>
          <pc:sldMasterMk cId="1117236912" sldId="2147483660"/>
        </pc:sldMasterMkLst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2104790935" sldId="2147483661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196089581" sldId="2147483662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3454129424" sldId="2147483663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4117553329" sldId="2147483664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2082942954" sldId="2147483665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446236687" sldId="2147483666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261481241" sldId="2147483667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3076372523" sldId="2147483668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579817931" sldId="2147483669"/>
          </pc:sldLayoutMkLst>
        </pc:sldLayoutChg>
        <pc:sldLayoutChg chg="del">
          <pc:chgData name="Abhishek Kumar" userId="cdeadaa3-b55e-4373-8448-bfeb5386a732" providerId="ADAL" clId="{3310C73A-675A-4853-BECC-5731EC7B0408}" dt="2024-10-15T12:28:22.470" v="53" actId="47"/>
          <pc:sldLayoutMkLst>
            <pc:docMk/>
            <pc:sldMasterMk cId="1117236912" sldId="2147483660"/>
            <pc:sldLayoutMk cId="2469065043" sldId="2147483670"/>
          </pc:sldLayoutMkLst>
        </pc:sldLayoutChg>
      </pc:sldMaster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https://kise-my.sharepoint.com/personal/abhishek_kumar_ki_se/Documents/Copied_from_OwnCloud/ABHI_05-15-2019_KI/KI/ONGOING%20Studies/2023_FredSilvestri/Manuscript/Project_BuccalTWENTY/Final/Attempt-Project-allbuccal_03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https://kise-my.sharepoint.com/personal/abhishek_kumar_ki_se/Documents/Copied_from_OwnCloud/ABHI_05-15-2019_KI/KI/ONGOING%20Studies/2023_FredSilvestri/Manuscript/Project_BuccalTWENTY/Final/Attempt-Project-allbuccal_03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https://kise-my.sharepoint.com/personal/abhishek_kumar_ki_se/Documents/Copied_from_OwnCloud/ABHI_05-15-2019_KI/KI/ONGOING%20Studies/2023_FredSilvestri/Manuscript/Project_BuccalTWENTY/Final/Attempt-Project-allbuccal_03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Attempt-Project-allbuccal_03.xlsx]StatisticalAnalysis'!$CK$130</c:f>
              <c:strCache>
                <c:ptCount val="1"/>
                <c:pt idx="0">
                  <c:v>Novices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[Attempt-Project-allbuccal_03.xlsx]StatisticalAnalysis'!$CJ$131:$CJ$139</c:f>
              <c:strCache>
                <c:ptCount val="9"/>
                <c:pt idx="0">
                  <c:v>Buccal wall</c:v>
                </c:pt>
                <c:pt idx="1">
                  <c:v>Height</c:v>
                </c:pt>
                <c:pt idx="2">
                  <c:v>Margin</c:v>
                </c:pt>
                <c:pt idx="3">
                  <c:v>Adjacent distal</c:v>
                </c:pt>
                <c:pt idx="4">
                  <c:v>Adjacent mesial</c:v>
                </c:pt>
                <c:pt idx="5">
                  <c:v>Occlusal</c:v>
                </c:pt>
                <c:pt idx="6">
                  <c:v>Taper distal</c:v>
                </c:pt>
                <c:pt idx="7">
                  <c:v>Taper mesial</c:v>
                </c:pt>
                <c:pt idx="8">
                  <c:v>Others</c:v>
                </c:pt>
              </c:strCache>
            </c:strRef>
          </c:cat>
          <c:val>
            <c:numRef>
              <c:f>'[Attempt-Project-allbuccal_03.xlsx]StatisticalAnalysis'!$CK$131:$CK$139</c:f>
              <c:numCache>
                <c:formatCode>General</c:formatCode>
                <c:ptCount val="9"/>
                <c:pt idx="0">
                  <c:v>17.600000000000001</c:v>
                </c:pt>
                <c:pt idx="1">
                  <c:v>3</c:v>
                </c:pt>
                <c:pt idx="2">
                  <c:v>26.5</c:v>
                </c:pt>
                <c:pt idx="3">
                  <c:v>3.3</c:v>
                </c:pt>
                <c:pt idx="4">
                  <c:v>1.7</c:v>
                </c:pt>
                <c:pt idx="5">
                  <c:v>15.3</c:v>
                </c:pt>
                <c:pt idx="6">
                  <c:v>7</c:v>
                </c:pt>
                <c:pt idx="7">
                  <c:v>6.7</c:v>
                </c:pt>
                <c:pt idx="8">
                  <c:v>18.8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C5-438A-AF06-76B15AE465D7}"/>
            </c:ext>
          </c:extLst>
        </c:ser>
        <c:ser>
          <c:idx val="1"/>
          <c:order val="1"/>
          <c:tx>
            <c:strRef>
              <c:f>'[Attempt-Project-allbuccal_03.xlsx]StatisticalAnalysis'!$CL$130</c:f>
              <c:strCache>
                <c:ptCount val="1"/>
                <c:pt idx="0">
                  <c:v>Experts</c:v>
                </c:pt>
              </c:strCache>
            </c:strRef>
          </c:tx>
          <c:spPr>
            <a:solidFill>
              <a:sysClr val="window" lastClr="FFFFFF">
                <a:lumMod val="95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[Attempt-Project-allbuccal_03.xlsx]StatisticalAnalysis'!$CJ$131:$CJ$139</c:f>
              <c:strCache>
                <c:ptCount val="9"/>
                <c:pt idx="0">
                  <c:v>Buccal wall</c:v>
                </c:pt>
                <c:pt idx="1">
                  <c:v>Height</c:v>
                </c:pt>
                <c:pt idx="2">
                  <c:v>Margin</c:v>
                </c:pt>
                <c:pt idx="3">
                  <c:v>Adjacent distal</c:v>
                </c:pt>
                <c:pt idx="4">
                  <c:v>Adjacent mesial</c:v>
                </c:pt>
                <c:pt idx="5">
                  <c:v>Occlusal</c:v>
                </c:pt>
                <c:pt idx="6">
                  <c:v>Taper distal</c:v>
                </c:pt>
                <c:pt idx="7">
                  <c:v>Taper mesial</c:v>
                </c:pt>
                <c:pt idx="8">
                  <c:v>Others</c:v>
                </c:pt>
              </c:strCache>
            </c:strRef>
          </c:cat>
          <c:val>
            <c:numRef>
              <c:f>'[Attempt-Project-allbuccal_03.xlsx]StatisticalAnalysis'!$CL$131:$CL$139</c:f>
              <c:numCache>
                <c:formatCode>General</c:formatCode>
                <c:ptCount val="9"/>
                <c:pt idx="0">
                  <c:v>23.2</c:v>
                </c:pt>
                <c:pt idx="1">
                  <c:v>1.4</c:v>
                </c:pt>
                <c:pt idx="2">
                  <c:v>28.2</c:v>
                </c:pt>
                <c:pt idx="3">
                  <c:v>3.1</c:v>
                </c:pt>
                <c:pt idx="4">
                  <c:v>2.1</c:v>
                </c:pt>
                <c:pt idx="5">
                  <c:v>9.1999999999999993</c:v>
                </c:pt>
                <c:pt idx="6">
                  <c:v>5.6</c:v>
                </c:pt>
                <c:pt idx="7">
                  <c:v>5.9</c:v>
                </c:pt>
                <c:pt idx="8">
                  <c:v>2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8C5-438A-AF06-76B15AE465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1141215"/>
        <c:axId val="1311141695"/>
      </c:barChart>
      <c:catAx>
        <c:axId val="131114121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ea of Interes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311141695"/>
        <c:crosses val="autoZero"/>
        <c:auto val="1"/>
        <c:lblAlgn val="ctr"/>
        <c:lblOffset val="100"/>
        <c:noMultiLvlLbl val="0"/>
      </c:catAx>
      <c:valAx>
        <c:axId val="131114169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erce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31114121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800" b="1">
                <a:solidFill>
                  <a:sysClr val="windowText" lastClr="000000"/>
                </a:solidFill>
              </a:rPr>
              <a:t>Total duration of fixation 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ttempt-Project-allbuccal_03.xlsx]Figures'!$G$284:$G$291</c:f>
                <c:numCache>
                  <c:formatCode>General</c:formatCode>
                  <c:ptCount val="8"/>
                  <c:pt idx="0">
                    <c:v>200.57703830329166</c:v>
                  </c:pt>
                  <c:pt idx="1">
                    <c:v>33.340410185306538</c:v>
                  </c:pt>
                  <c:pt idx="2">
                    <c:v>259.44299002201069</c:v>
                  </c:pt>
                  <c:pt idx="3">
                    <c:v>72.122517371077834</c:v>
                  </c:pt>
                  <c:pt idx="4">
                    <c:v>37.186569829674248</c:v>
                  </c:pt>
                  <c:pt idx="5">
                    <c:v>156.09524336332649</c:v>
                  </c:pt>
                  <c:pt idx="6">
                    <c:v>123.03017018409558</c:v>
                  </c:pt>
                  <c:pt idx="7">
                    <c:v>124.89932989113309</c:v>
                  </c:pt>
                </c:numCache>
              </c:numRef>
            </c:plus>
            <c:minus>
              <c:numRef>
                <c:f>'[Attempt-Project-allbuccal_03.xlsx]Figures'!$G$284:$G$291</c:f>
                <c:numCache>
                  <c:formatCode>General</c:formatCode>
                  <c:ptCount val="8"/>
                  <c:pt idx="0">
                    <c:v>200.57703830329166</c:v>
                  </c:pt>
                  <c:pt idx="1">
                    <c:v>33.340410185306538</c:v>
                  </c:pt>
                  <c:pt idx="2">
                    <c:v>259.44299002201069</c:v>
                  </c:pt>
                  <c:pt idx="3">
                    <c:v>72.122517371077834</c:v>
                  </c:pt>
                  <c:pt idx="4">
                    <c:v>37.186569829674248</c:v>
                  </c:pt>
                  <c:pt idx="5">
                    <c:v>156.09524336332649</c:v>
                  </c:pt>
                  <c:pt idx="6">
                    <c:v>123.03017018409558</c:v>
                  </c:pt>
                  <c:pt idx="7">
                    <c:v>124.89932989113309</c:v>
                  </c:pt>
                </c:numCache>
              </c:numRef>
            </c:minus>
          </c:errBars>
          <c:cat>
            <c:strRef>
              <c:f>'[Attempt-Project-allbuccal_03.xlsx]Figures'!$C$284:$C$291</c:f>
              <c:strCache>
                <c:ptCount val="8"/>
                <c:pt idx="0">
                  <c:v>Bucca wall</c:v>
                </c:pt>
                <c:pt idx="1">
                  <c:v>Height</c:v>
                </c:pt>
                <c:pt idx="2">
                  <c:v>Margin</c:v>
                </c:pt>
                <c:pt idx="3">
                  <c:v>Neig_D</c:v>
                </c:pt>
                <c:pt idx="4">
                  <c:v>Neig_M</c:v>
                </c:pt>
                <c:pt idx="5">
                  <c:v>Occlusal</c:v>
                </c:pt>
                <c:pt idx="6">
                  <c:v>Taper_M</c:v>
                </c:pt>
                <c:pt idx="7">
                  <c:v>Taper_D</c:v>
                </c:pt>
              </c:strCache>
            </c:strRef>
          </c:cat>
          <c:val>
            <c:numRef>
              <c:f>'[Attempt-Project-allbuccal_03.xlsx]Figures'!$E$284:$E$291</c:f>
              <c:numCache>
                <c:formatCode>General</c:formatCode>
                <c:ptCount val="8"/>
                <c:pt idx="0">
                  <c:v>1867.1294117647058</c:v>
                </c:pt>
                <c:pt idx="1">
                  <c:v>115.0764705882353</c:v>
                </c:pt>
                <c:pt idx="2">
                  <c:v>2125.0882352941171</c:v>
                </c:pt>
                <c:pt idx="3">
                  <c:v>268.54411764705878</c:v>
                </c:pt>
                <c:pt idx="4">
                  <c:v>185.61470588235292</c:v>
                </c:pt>
                <c:pt idx="5">
                  <c:v>788.05882352941171</c:v>
                </c:pt>
                <c:pt idx="6">
                  <c:v>528.06764705882347</c:v>
                </c:pt>
                <c:pt idx="7">
                  <c:v>498.188235294117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D3-4B95-AE07-31E4365833E1}"/>
            </c:ext>
          </c:extLst>
        </c:ser>
        <c:ser>
          <c:idx val="1"/>
          <c:order val="1"/>
          <c:spPr>
            <a:solidFill>
              <a:sysClr val="window" lastClr="FFFFFF">
                <a:lumMod val="95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ttempt-Project-allbuccal_03.xlsx]Figures'!$G$294:$G$301</c:f>
                <c:numCache>
                  <c:formatCode>General</c:formatCode>
                  <c:ptCount val="8"/>
                  <c:pt idx="0">
                    <c:v>221.3022390865593</c:v>
                  </c:pt>
                  <c:pt idx="1">
                    <c:v>73.894658393208303</c:v>
                  </c:pt>
                  <c:pt idx="2">
                    <c:v>371.28623251239458</c:v>
                  </c:pt>
                  <c:pt idx="3">
                    <c:v>65.973701320094321</c:v>
                  </c:pt>
                  <c:pt idx="4">
                    <c:v>40.28614704366894</c:v>
                  </c:pt>
                  <c:pt idx="5">
                    <c:v>149.98056729581543</c:v>
                  </c:pt>
                  <c:pt idx="6">
                    <c:v>129.71126294499842</c:v>
                  </c:pt>
                  <c:pt idx="7">
                    <c:v>103.73306672936631</c:v>
                  </c:pt>
                </c:numCache>
              </c:numRef>
            </c:plus>
            <c:minus>
              <c:numRef>
                <c:f>'[Attempt-Project-allbuccal_03.xlsx]Figures'!$G$294:$G$301</c:f>
                <c:numCache>
                  <c:formatCode>General</c:formatCode>
                  <c:ptCount val="8"/>
                  <c:pt idx="0">
                    <c:v>221.3022390865593</c:v>
                  </c:pt>
                  <c:pt idx="1">
                    <c:v>73.894658393208303</c:v>
                  </c:pt>
                  <c:pt idx="2">
                    <c:v>371.28623251239458</c:v>
                  </c:pt>
                  <c:pt idx="3">
                    <c:v>65.973701320094321</c:v>
                  </c:pt>
                  <c:pt idx="4">
                    <c:v>40.28614704366894</c:v>
                  </c:pt>
                  <c:pt idx="5">
                    <c:v>149.98056729581543</c:v>
                  </c:pt>
                  <c:pt idx="6">
                    <c:v>129.71126294499842</c:v>
                  </c:pt>
                  <c:pt idx="7">
                    <c:v>103.73306672936631</c:v>
                  </c:pt>
                </c:numCache>
              </c:numRef>
            </c:minus>
          </c:errBars>
          <c:val>
            <c:numRef>
              <c:f>'[Attempt-Project-allbuccal_03.xlsx]Figures'!$E$294:$E$301</c:f>
              <c:numCache>
                <c:formatCode>General</c:formatCode>
                <c:ptCount val="8"/>
                <c:pt idx="0">
                  <c:v>1654.3805555555557</c:v>
                </c:pt>
                <c:pt idx="1">
                  <c:v>268.40833333333336</c:v>
                </c:pt>
                <c:pt idx="2">
                  <c:v>2823.9333333333338</c:v>
                </c:pt>
                <c:pt idx="3">
                  <c:v>369.49166666666667</c:v>
                </c:pt>
                <c:pt idx="4">
                  <c:v>186.85833333333335</c:v>
                </c:pt>
                <c:pt idx="5">
                  <c:v>1522.0055555555557</c:v>
                </c:pt>
                <c:pt idx="6">
                  <c:v>732.11388888888882</c:v>
                </c:pt>
                <c:pt idx="7">
                  <c:v>754.586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D3-4B95-AE07-31E4365833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5341471"/>
        <c:axId val="109076223"/>
      </c:barChart>
      <c:catAx>
        <c:axId val="515341471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AOIs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9076223"/>
        <c:crosses val="autoZero"/>
        <c:auto val="1"/>
        <c:lblAlgn val="ctr"/>
        <c:lblOffset val="100"/>
        <c:noMultiLvlLbl val="0"/>
      </c:catAx>
      <c:valAx>
        <c:axId val="109076223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m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53414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fr-FR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1">
                <a:solidFill>
                  <a:sysClr val="windowText" lastClr="000000"/>
                </a:solidFill>
              </a:rPr>
              <a:t>Fixations</a:t>
            </a:r>
            <a:endParaRPr lang="en-US" b="1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ttempt-Project-allbuccal_03.xlsx]Figures'!$J$284:$J$291</c:f>
                <c:numCache>
                  <c:formatCode>General</c:formatCode>
                  <c:ptCount val="8"/>
                  <c:pt idx="0">
                    <c:v>0.59045492273493949</c:v>
                  </c:pt>
                  <c:pt idx="1">
                    <c:v>0.11042162323430521</c:v>
                  </c:pt>
                  <c:pt idx="2">
                    <c:v>0.50850751166680253</c:v>
                  </c:pt>
                  <c:pt idx="3">
                    <c:v>0.19372425784559044</c:v>
                  </c:pt>
                  <c:pt idx="4">
                    <c:v>0.11787947918758107</c:v>
                  </c:pt>
                  <c:pt idx="5">
                    <c:v>0.50996667134122997</c:v>
                  </c:pt>
                  <c:pt idx="6">
                    <c:v>0.23878234164966364</c:v>
                  </c:pt>
                  <c:pt idx="7">
                    <c:v>0.25202794036350179</c:v>
                  </c:pt>
                </c:numCache>
              </c:numRef>
            </c:plus>
            <c:minus>
              <c:numRef>
                <c:f>'[Attempt-Project-allbuccal_03.xlsx]Figures'!$J$284:$J$291</c:f>
                <c:numCache>
                  <c:formatCode>General</c:formatCode>
                  <c:ptCount val="8"/>
                  <c:pt idx="0">
                    <c:v>0.59045492273493949</c:v>
                  </c:pt>
                  <c:pt idx="1">
                    <c:v>0.11042162323430521</c:v>
                  </c:pt>
                  <c:pt idx="2">
                    <c:v>0.50850751166680253</c:v>
                  </c:pt>
                  <c:pt idx="3">
                    <c:v>0.19372425784559044</c:v>
                  </c:pt>
                  <c:pt idx="4">
                    <c:v>0.11787947918758107</c:v>
                  </c:pt>
                  <c:pt idx="5">
                    <c:v>0.50996667134122997</c:v>
                  </c:pt>
                  <c:pt idx="6">
                    <c:v>0.23878234164966364</c:v>
                  </c:pt>
                  <c:pt idx="7">
                    <c:v>0.25202794036350179</c:v>
                  </c:pt>
                </c:numCache>
              </c:numRef>
            </c:minus>
          </c:errBars>
          <c:cat>
            <c:strRef>
              <c:f>'[Attempt-Project-allbuccal_03.xlsx]Figures'!$C$284:$C$291</c:f>
              <c:strCache>
                <c:ptCount val="8"/>
                <c:pt idx="0">
                  <c:v>Bucca wall</c:v>
                </c:pt>
                <c:pt idx="1">
                  <c:v>Height</c:v>
                </c:pt>
                <c:pt idx="2">
                  <c:v>Margin</c:v>
                </c:pt>
                <c:pt idx="3">
                  <c:v>Neig_D</c:v>
                </c:pt>
                <c:pt idx="4">
                  <c:v>Neig_M</c:v>
                </c:pt>
                <c:pt idx="5">
                  <c:v>Occlusal</c:v>
                </c:pt>
                <c:pt idx="6">
                  <c:v>Taper_M</c:v>
                </c:pt>
                <c:pt idx="7">
                  <c:v>Taper_D</c:v>
                </c:pt>
              </c:strCache>
            </c:strRef>
          </c:cat>
          <c:val>
            <c:numRef>
              <c:f>'[Attempt-Project-allbuccal_03.xlsx]Figures'!$H$284:$H$291</c:f>
              <c:numCache>
                <c:formatCode>General</c:formatCode>
                <c:ptCount val="8"/>
                <c:pt idx="0">
                  <c:v>6.1058823529411752</c:v>
                </c:pt>
                <c:pt idx="1">
                  <c:v>0.40588235294117642</c:v>
                </c:pt>
                <c:pt idx="2">
                  <c:v>4.9617647058823522</c:v>
                </c:pt>
                <c:pt idx="3">
                  <c:v>0.78529411764705881</c:v>
                </c:pt>
                <c:pt idx="4">
                  <c:v>0.54705882352941182</c:v>
                </c:pt>
                <c:pt idx="5">
                  <c:v>2.5029411764705878</c:v>
                </c:pt>
                <c:pt idx="6">
                  <c:v>1.1205882352941174</c:v>
                </c:pt>
                <c:pt idx="7">
                  <c:v>1.16470588235294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02-46B6-B1AC-4711F908CC14}"/>
            </c:ext>
          </c:extLst>
        </c:ser>
        <c:ser>
          <c:idx val="1"/>
          <c:order val="1"/>
          <c:spPr>
            <a:solidFill>
              <a:sysClr val="window" lastClr="FFFFFF">
                <a:lumMod val="95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ttempt-Project-allbuccal_03.xlsx]Figures'!$J$294:$J$301</c:f>
                <c:numCache>
                  <c:formatCode>General</c:formatCode>
                  <c:ptCount val="8"/>
                  <c:pt idx="0">
                    <c:v>0.55542256978425253</c:v>
                  </c:pt>
                  <c:pt idx="1">
                    <c:v>0.31580450533016041</c:v>
                  </c:pt>
                  <c:pt idx="2">
                    <c:v>0.74047242511624622</c:v>
                  </c:pt>
                  <c:pt idx="3">
                    <c:v>0.19757526354348112</c:v>
                  </c:pt>
                  <c:pt idx="4">
                    <c:v>9.4181817526355308E-2</c:v>
                  </c:pt>
                  <c:pt idx="5">
                    <c:v>0.48326330024837061</c:v>
                  </c:pt>
                  <c:pt idx="6">
                    <c:v>0.19382774400070904</c:v>
                  </c:pt>
                  <c:pt idx="7">
                    <c:v>0.16145679821378264</c:v>
                  </c:pt>
                </c:numCache>
              </c:numRef>
            </c:plus>
            <c:minus>
              <c:numRef>
                <c:f>'[Attempt-Project-allbuccal_03.xlsx]Figures'!$J$294:$J$301</c:f>
                <c:numCache>
                  <c:formatCode>General</c:formatCode>
                  <c:ptCount val="8"/>
                  <c:pt idx="0">
                    <c:v>0.55542256978425253</c:v>
                  </c:pt>
                  <c:pt idx="1">
                    <c:v>0.31580450533016041</c:v>
                  </c:pt>
                  <c:pt idx="2">
                    <c:v>0.74047242511624622</c:v>
                  </c:pt>
                  <c:pt idx="3">
                    <c:v>0.19757526354348112</c:v>
                  </c:pt>
                  <c:pt idx="4">
                    <c:v>9.4181817526355308E-2</c:v>
                  </c:pt>
                  <c:pt idx="5">
                    <c:v>0.48326330024837061</c:v>
                  </c:pt>
                  <c:pt idx="6">
                    <c:v>0.19382774400070904</c:v>
                  </c:pt>
                  <c:pt idx="7">
                    <c:v>0.16145679821378264</c:v>
                  </c:pt>
                </c:numCache>
              </c:numRef>
            </c:minus>
          </c:errBars>
          <c:val>
            <c:numRef>
              <c:f>'[Attempt-Project-allbuccal_03.xlsx]Figures'!$H$294:$H$301</c:f>
              <c:numCache>
                <c:formatCode>General</c:formatCode>
                <c:ptCount val="8"/>
                <c:pt idx="0">
                  <c:v>5.5250000000000012</c:v>
                </c:pt>
                <c:pt idx="1">
                  <c:v>1.0611111111111109</c:v>
                </c:pt>
                <c:pt idx="2">
                  <c:v>6.2638888888888893</c:v>
                </c:pt>
                <c:pt idx="3">
                  <c:v>1.1222222222222225</c:v>
                </c:pt>
                <c:pt idx="4">
                  <c:v>0.56666666666666676</c:v>
                </c:pt>
                <c:pt idx="5">
                  <c:v>4.8833333333333337</c:v>
                </c:pt>
                <c:pt idx="6">
                  <c:v>1.4083333333333334</c:v>
                </c:pt>
                <c:pt idx="7">
                  <c:v>1.4472222222222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602-46B6-B1AC-4711F908CC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5341471"/>
        <c:axId val="109076223"/>
      </c:barChart>
      <c:catAx>
        <c:axId val="515341471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1" i="0" u="none" strike="noStrike" kern="1200" baseline="0" dirty="0">
                    <a:solidFill>
                      <a:prstClr val="black"/>
                    </a:solidFill>
                  </a:rPr>
                  <a:t>AOIs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9076223"/>
        <c:crosses val="autoZero"/>
        <c:auto val="1"/>
        <c:lblAlgn val="ctr"/>
        <c:lblOffset val="100"/>
        <c:noMultiLvlLbl val="0"/>
      </c:catAx>
      <c:valAx>
        <c:axId val="109076223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n</a:t>
                </a:r>
              </a:p>
            </c:rich>
          </c:tx>
          <c:layout>
            <c:manualLayout>
              <c:xMode val="edge"/>
              <c:yMode val="edge"/>
              <c:x val="3.0555574620245673E-2"/>
              <c:y val="0.465532664581310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53414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fr-FR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800" b="1">
                <a:solidFill>
                  <a:sysClr val="windowText" lastClr="000000"/>
                </a:solidFill>
              </a:rPr>
              <a:t>Time to first fixation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50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ttempt-Project-allbuccal_03.xlsx]Figures'!$M$284:$M$291</c:f>
                <c:numCache>
                  <c:formatCode>General</c:formatCode>
                  <c:ptCount val="8"/>
                  <c:pt idx="0">
                    <c:v>67.691181118124391</c:v>
                  </c:pt>
                  <c:pt idx="1">
                    <c:v>662.01637901051208</c:v>
                  </c:pt>
                  <c:pt idx="2">
                    <c:v>208.63689485332299</c:v>
                  </c:pt>
                  <c:pt idx="3">
                    <c:v>463.31478406786124</c:v>
                  </c:pt>
                  <c:pt idx="4">
                    <c:v>446.63837391508258</c:v>
                  </c:pt>
                  <c:pt idx="5">
                    <c:v>279.81402447528939</c:v>
                  </c:pt>
                  <c:pt idx="6">
                    <c:v>259.29725681690184</c:v>
                  </c:pt>
                  <c:pt idx="7">
                    <c:v>247.21514952143028</c:v>
                  </c:pt>
                </c:numCache>
              </c:numRef>
            </c:plus>
            <c:minus>
              <c:numRef>
                <c:f>'[Attempt-Project-allbuccal_03.xlsx]Figures'!$M$284:$M$291</c:f>
                <c:numCache>
                  <c:formatCode>General</c:formatCode>
                  <c:ptCount val="8"/>
                  <c:pt idx="0">
                    <c:v>67.691181118124391</c:v>
                  </c:pt>
                  <c:pt idx="1">
                    <c:v>662.01637901051208</c:v>
                  </c:pt>
                  <c:pt idx="2">
                    <c:v>208.63689485332299</c:v>
                  </c:pt>
                  <c:pt idx="3">
                    <c:v>463.31478406786124</c:v>
                  </c:pt>
                  <c:pt idx="4">
                    <c:v>446.63837391508258</c:v>
                  </c:pt>
                  <c:pt idx="5">
                    <c:v>279.81402447528939</c:v>
                  </c:pt>
                  <c:pt idx="6">
                    <c:v>259.29725681690184</c:v>
                  </c:pt>
                  <c:pt idx="7">
                    <c:v>247.21514952143028</c:v>
                  </c:pt>
                </c:numCache>
              </c:numRef>
            </c:minus>
          </c:errBars>
          <c:cat>
            <c:strRef>
              <c:f>'[Attempt-Project-allbuccal_03.xlsx]Figures'!$C$284:$C$291</c:f>
              <c:strCache>
                <c:ptCount val="8"/>
                <c:pt idx="0">
                  <c:v>Bucca wall</c:v>
                </c:pt>
                <c:pt idx="1">
                  <c:v>Height</c:v>
                </c:pt>
                <c:pt idx="2">
                  <c:v>Margin</c:v>
                </c:pt>
                <c:pt idx="3">
                  <c:v>Neig_D</c:v>
                </c:pt>
                <c:pt idx="4">
                  <c:v>Neig_M</c:v>
                </c:pt>
                <c:pt idx="5">
                  <c:v>Occlusal</c:v>
                </c:pt>
                <c:pt idx="6">
                  <c:v>Taper_M</c:v>
                </c:pt>
                <c:pt idx="7">
                  <c:v>Taper_D</c:v>
                </c:pt>
              </c:strCache>
            </c:strRef>
          </c:cat>
          <c:val>
            <c:numRef>
              <c:f>'[Attempt-Project-allbuccal_03.xlsx]Figures'!$K$284:$K$291</c:f>
              <c:numCache>
                <c:formatCode>General</c:formatCode>
                <c:ptCount val="8"/>
                <c:pt idx="0">
                  <c:v>337.40091159270725</c:v>
                </c:pt>
                <c:pt idx="1">
                  <c:v>3683.2915929202959</c:v>
                </c:pt>
                <c:pt idx="2">
                  <c:v>1354.9901877314394</c:v>
                </c:pt>
                <c:pt idx="3">
                  <c:v>3184.1897058823529</c:v>
                </c:pt>
                <c:pt idx="4">
                  <c:v>3185.5058837173024</c:v>
                </c:pt>
                <c:pt idx="5">
                  <c:v>2853.3399537890023</c:v>
                </c:pt>
                <c:pt idx="6">
                  <c:v>3040.3554397872522</c:v>
                </c:pt>
                <c:pt idx="7">
                  <c:v>2462.6409313725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51-4E1F-8F58-9B32FE60CCC3}"/>
            </c:ext>
          </c:extLst>
        </c:ser>
        <c:ser>
          <c:idx val="1"/>
          <c:order val="1"/>
          <c:spPr>
            <a:solidFill>
              <a:sysClr val="window" lastClr="FFFFFF">
                <a:lumMod val="95000"/>
              </a:sys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ttempt-Project-allbuccal_03.xlsx]Figures'!$M$294:$M$301</c:f>
                <c:numCache>
                  <c:formatCode>General</c:formatCode>
                  <c:ptCount val="8"/>
                  <c:pt idx="0">
                    <c:v>164.8711987795281</c:v>
                  </c:pt>
                  <c:pt idx="1">
                    <c:v>669.59498263336104</c:v>
                  </c:pt>
                  <c:pt idx="2">
                    <c:v>144.69787820859557</c:v>
                  </c:pt>
                  <c:pt idx="3">
                    <c:v>475.19274394142764</c:v>
                  </c:pt>
                  <c:pt idx="4">
                    <c:v>506.30212847926322</c:v>
                  </c:pt>
                  <c:pt idx="5">
                    <c:v>286.34750791964933</c:v>
                  </c:pt>
                  <c:pt idx="6">
                    <c:v>363.89505422422212</c:v>
                  </c:pt>
                  <c:pt idx="7">
                    <c:v>336.70132725232639</c:v>
                  </c:pt>
                </c:numCache>
              </c:numRef>
            </c:plus>
            <c:minus>
              <c:numRef>
                <c:f>'[Attempt-Project-allbuccal_03.xlsx]Figures'!$M$294:$M$301</c:f>
                <c:numCache>
                  <c:formatCode>General</c:formatCode>
                  <c:ptCount val="8"/>
                  <c:pt idx="0">
                    <c:v>164.8711987795281</c:v>
                  </c:pt>
                  <c:pt idx="1">
                    <c:v>669.59498263336104</c:v>
                  </c:pt>
                  <c:pt idx="2">
                    <c:v>144.69787820859557</c:v>
                  </c:pt>
                  <c:pt idx="3">
                    <c:v>475.19274394142764</c:v>
                  </c:pt>
                  <c:pt idx="4">
                    <c:v>506.30212847926322</c:v>
                  </c:pt>
                  <c:pt idx="5">
                    <c:v>286.34750791964933</c:v>
                  </c:pt>
                  <c:pt idx="6">
                    <c:v>363.89505422422212</c:v>
                  </c:pt>
                  <c:pt idx="7">
                    <c:v>336.70132725232639</c:v>
                  </c:pt>
                </c:numCache>
              </c:numRef>
            </c:minus>
          </c:errBars>
          <c:val>
            <c:numRef>
              <c:f>'[Attempt-Project-allbuccal_03.xlsx]Figures'!$K$294:$K$301</c:f>
              <c:numCache>
                <c:formatCode>General</c:formatCode>
                <c:ptCount val="8"/>
                <c:pt idx="0">
                  <c:v>773.86705653021431</c:v>
                </c:pt>
                <c:pt idx="1">
                  <c:v>5338.5493018507295</c:v>
                </c:pt>
                <c:pt idx="2">
                  <c:v>1399.5721116359273</c:v>
                </c:pt>
                <c:pt idx="3">
                  <c:v>4455.2859588849788</c:v>
                </c:pt>
                <c:pt idx="4">
                  <c:v>4378.3803187553176</c:v>
                </c:pt>
                <c:pt idx="5">
                  <c:v>2156.7526508264123</c:v>
                </c:pt>
                <c:pt idx="6">
                  <c:v>3215.3469615597778</c:v>
                </c:pt>
                <c:pt idx="7">
                  <c:v>3273.73293222205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51-4E1F-8F58-9B32FE60CC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5341471"/>
        <c:axId val="109076223"/>
      </c:barChart>
      <c:catAx>
        <c:axId val="515341471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1" i="0" u="none" strike="noStrike" kern="1200" baseline="0" dirty="0">
                    <a:solidFill>
                      <a:prstClr val="black"/>
                    </a:solidFill>
                  </a:rPr>
                  <a:t>AOIs</a:t>
                </a:r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9076223"/>
        <c:crosses val="autoZero"/>
        <c:auto val="1"/>
        <c:lblAlgn val="ctr"/>
        <c:lblOffset val="100"/>
        <c:noMultiLvlLbl val="0"/>
      </c:catAx>
      <c:valAx>
        <c:axId val="109076223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1000" b="1" i="0" u="none" strike="noStrike" kern="1200" baseline="0" dirty="0">
                    <a:solidFill>
                      <a:prstClr val="black"/>
                    </a:solidFill>
                  </a:rPr>
                  <a:t>m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53414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fr-FR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0279E9-2401-4441-83DE-FDDF91852E55}" type="datetimeFigureOut">
              <a:rPr lang="en-US" smtClean="0"/>
              <a:t>6/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B5485-5772-4B4C-817C-BD93ADD02A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261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6AD637E-766A-46FD-9874-1DD387AB4D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AFF783A-6133-5AD8-B1AA-0C7A7E06BB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D6A6095-0E48-7A08-158E-42C481819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E708065-1551-DEF0-49B8-5C36B6DA9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6E3506B-2DE3-44C9-6EA5-BA95E4805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1422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A12ABF-6040-A095-B4FB-CAD936304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2232675-1D7E-CAC3-5866-B771442D4E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84D44BC-6048-AAAF-9FA8-BACC3123C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F47E62-A8B9-CB38-C3FA-42B52D903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C6EBFEC-3F4D-CBDB-01AF-0B94B345B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6499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F1691E9-30FA-EA60-812D-E391CEFA2B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9C1703B-255A-059F-4179-BA8BAB09B6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E061D7-C236-9692-1282-4FE60C7D2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D5C3A59-75DA-0E65-843B-90A304D17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3D141E2-5B19-B3CD-C7E2-01F8D0752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662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6BA7CC8-18FF-5C4C-E0C6-A47B080CF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2251DA7-65DB-7E7E-85B9-5D94B1B978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C3EBF5B-D019-4FF4-2A42-752C01C08D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CE02625-7249-8E19-1B47-A8E983BE0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80C6955-BF97-68EA-09E7-FF04CAB68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9271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6D362EE-0D3A-DADF-1AED-1CCAC7F735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4115F0B-2C2F-C648-2E95-44B08B0DA2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82C38CC-9D8D-0024-9634-48D399D09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36CE83F-9046-61D0-EE7A-A369A1748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F1E2634-B94F-2794-0DB3-01B6E293A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2946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DBADDD1-5486-C3A5-85C6-E98FBE8942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13F24DD-8430-0E1D-7B77-BF2135B9F6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7D7EC4A-5D84-96AE-FEEB-10E8720C72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5CAE6B4-8CBD-86B6-427B-A8154AA70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149B58-BD3B-AEAC-E307-31B1548A5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7CA7BB0-ED13-F031-E69E-ECB717349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837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0B73ED8-8AB8-3DE4-91C6-1D199F6201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A1AA566-1774-B0D6-455B-95D4B40C1B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BAC6812-D588-1612-242B-CF278FFB6B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480678E-B94E-D790-EE48-D64FF7C12B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9B49EFA-E2CF-925F-2CA2-FD4B25507F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111206E-647C-0BF9-677C-E235A4003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BDCC27F-C1FC-53CF-2C76-B1F7AC40E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BDF4144-4B11-C01B-3A59-5011D1F43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2821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BD23788-19B4-45FD-673D-5CF64BEC4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2368656-D4F8-3AB5-D9C7-11634F7D6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505A23F-FD5D-F030-6EE8-559279E7DA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1BC7CB0-9B41-8AEA-4962-81CAF1EF0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6977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94508460-05AE-B152-29D8-29D6C9BB1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A59756B-4FE5-2F07-245F-5F82F0538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7E33CB9-F95F-2156-4C8A-2C171211B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5221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46D3247-8EEB-2F13-51E7-69A0390A47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A44BCCE-1697-61B7-EC05-9DB461B2CB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23149D8-98FB-FEA2-BF9B-424FE4836D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3B0C3BB-E86D-D3A1-7E8A-83120D41C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2109182-0DB8-5F4D-7A03-DD2567CC5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D7B3B4-064D-067A-8BCB-A0D7758E5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4744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3B0AC65-4BB2-B9A5-3B7F-73AC37642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2A59C76-2A95-760B-B952-EFF3FC0A17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2E70939-297E-387E-CE6E-D6BC85102A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C9DA9FD-520B-BFF6-777B-F67C0E95A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A5BF38-90EB-5FA7-969D-7EFA11CD8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86D68BC-105C-8A76-C39F-2E72B6728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75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21EF67D-B1D5-5B25-F019-339A285470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792C9C7-3F3B-B27C-B4E0-ADBE17A6D3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AA09D81-A4C5-7662-B899-134C898BAD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76E70F6-1C32-EC4E-9FB2-AD590E1BA0E6}" type="datetimeFigureOut">
              <a:rPr lang="fr-FR" smtClean="0"/>
              <a:t>02/06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7E82616-B255-A332-30D6-B24B8783C3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7AAF53D-D9D6-895E-F5C9-298D469381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3B33BD-D99D-C740-A6D5-45AD780AFC8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2703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598878B-0934-5417-184D-C7010DBF88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1055" y="440252"/>
            <a:ext cx="10038065" cy="580509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950A171-448C-BFF7-1CD0-61486C2577AC}"/>
              </a:ext>
            </a:extLst>
          </p:cNvPr>
          <p:cNvSpPr txBox="1"/>
          <p:nvPr/>
        </p:nvSpPr>
        <p:spPr>
          <a:xfrm>
            <a:off x="347472" y="832104"/>
            <a:ext cx="7876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. 1</a:t>
            </a:r>
          </a:p>
        </p:txBody>
      </p:sp>
    </p:spTree>
    <p:extLst>
      <p:ext uri="{BB962C8B-B14F-4D97-AF65-F5344CB8AC3E}">
        <p14:creationId xmlns:p14="http://schemas.microsoft.com/office/powerpoint/2010/main" val="3847580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6E03C7E1-A7C3-B5DC-0259-36E350766F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2497" y="264792"/>
            <a:ext cx="10300138" cy="570247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C6A9FCC-FEBD-A886-E896-671B5E2B613A}"/>
              </a:ext>
            </a:extLst>
          </p:cNvPr>
          <p:cNvSpPr txBox="1"/>
          <p:nvPr/>
        </p:nvSpPr>
        <p:spPr>
          <a:xfrm>
            <a:off x="347472" y="832104"/>
            <a:ext cx="7876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. 2</a:t>
            </a:r>
          </a:p>
        </p:txBody>
      </p:sp>
    </p:spTree>
    <p:extLst>
      <p:ext uri="{BB962C8B-B14F-4D97-AF65-F5344CB8AC3E}">
        <p14:creationId xmlns:p14="http://schemas.microsoft.com/office/powerpoint/2010/main" val="30656586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0000000-0008-0000-09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6039744"/>
              </p:ext>
            </p:extLst>
          </p:nvPr>
        </p:nvGraphicFramePr>
        <p:xfrm>
          <a:off x="1169192" y="1430964"/>
          <a:ext cx="9853615" cy="2990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264F2A1-3D1A-1DFD-792B-95B6DA87714D}"/>
              </a:ext>
            </a:extLst>
          </p:cNvPr>
          <p:cNvSpPr txBox="1"/>
          <p:nvPr/>
        </p:nvSpPr>
        <p:spPr>
          <a:xfrm>
            <a:off x="347472" y="832104"/>
            <a:ext cx="7876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. 3</a:t>
            </a:r>
          </a:p>
        </p:txBody>
      </p:sp>
    </p:spTree>
    <p:extLst>
      <p:ext uri="{BB962C8B-B14F-4D97-AF65-F5344CB8AC3E}">
        <p14:creationId xmlns:p14="http://schemas.microsoft.com/office/powerpoint/2010/main" val="34296985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C8DD39B-3F54-18CE-8E0D-85956B9DC7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852" t="89871" r="37670" b="1834"/>
          <a:stretch/>
        </p:blipFill>
        <p:spPr>
          <a:xfrm>
            <a:off x="5000625" y="6128491"/>
            <a:ext cx="1540706" cy="3227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2800039-8580-CD14-0D22-14EB60B0A850}"/>
              </a:ext>
            </a:extLst>
          </p:cNvPr>
          <p:cNvSpPr txBox="1"/>
          <p:nvPr/>
        </p:nvSpPr>
        <p:spPr>
          <a:xfrm>
            <a:off x="347472" y="832104"/>
            <a:ext cx="7876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. 4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4389D34-8AB8-862E-95B0-E4F4D22AB29E}"/>
              </a:ext>
            </a:extLst>
          </p:cNvPr>
          <p:cNvGrpSpPr/>
          <p:nvPr/>
        </p:nvGrpSpPr>
        <p:grpSpPr>
          <a:xfrm>
            <a:off x="3523134" y="412929"/>
            <a:ext cx="4846320" cy="1828800"/>
            <a:chOff x="1213288" y="635529"/>
            <a:chExt cx="5405439" cy="2695575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EBB2D890-792B-A925-FAA4-FB2E005B80B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34991732"/>
                </p:ext>
              </p:extLst>
            </p:nvPr>
          </p:nvGraphicFramePr>
          <p:xfrm>
            <a:off x="1213288" y="635529"/>
            <a:ext cx="5405439" cy="26955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41F1F6E-9AA8-CCD3-7660-7FA6C4471B55}"/>
                </a:ext>
              </a:extLst>
            </p:cNvPr>
            <p:cNvSpPr txBox="1"/>
            <p:nvPr/>
          </p:nvSpPr>
          <p:spPr>
            <a:xfrm>
              <a:off x="1218617" y="635529"/>
              <a:ext cx="3209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D362EEA3-7ACA-9958-8635-D6CA35664906}"/>
              </a:ext>
            </a:extLst>
          </p:cNvPr>
          <p:cNvSpPr txBox="1"/>
          <p:nvPr/>
        </p:nvSpPr>
        <p:spPr>
          <a:xfrm>
            <a:off x="6771127" y="3429000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12647CBE-B4D8-3EAC-8FF2-FCCCA2B8BD4D}"/>
              </a:ext>
            </a:extLst>
          </p:cNvPr>
          <p:cNvGrpSpPr/>
          <p:nvPr/>
        </p:nvGrpSpPr>
        <p:grpSpPr>
          <a:xfrm>
            <a:off x="3523134" y="2301139"/>
            <a:ext cx="4846320" cy="1828800"/>
            <a:chOff x="6693488" y="635529"/>
            <a:chExt cx="5391393" cy="2695575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68948E94-0839-9D26-0D1C-4D0E3DC868F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62057838"/>
                </p:ext>
              </p:extLst>
            </p:nvPr>
          </p:nvGraphicFramePr>
          <p:xfrm>
            <a:off x="6693488" y="635529"/>
            <a:ext cx="5391393" cy="26955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90DA17A-C658-8700-9494-0B954D876418}"/>
                </a:ext>
              </a:extLst>
            </p:cNvPr>
            <p:cNvSpPr txBox="1"/>
            <p:nvPr/>
          </p:nvSpPr>
          <p:spPr>
            <a:xfrm>
              <a:off x="6771127" y="664041"/>
              <a:ext cx="360583" cy="5443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347FA390-CC04-59AD-CD6B-CBE7B9E2404A}"/>
              </a:ext>
            </a:extLst>
          </p:cNvPr>
          <p:cNvGrpSpPr/>
          <p:nvPr/>
        </p:nvGrpSpPr>
        <p:grpSpPr>
          <a:xfrm>
            <a:off x="3523134" y="4189963"/>
            <a:ext cx="4846320" cy="1828800"/>
            <a:chOff x="1217014" y="3412027"/>
            <a:chExt cx="5401713" cy="2752866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067AD267-AF97-5F23-4DE8-49252041502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36458630"/>
                </p:ext>
              </p:extLst>
            </p:nvPr>
          </p:nvGraphicFramePr>
          <p:xfrm>
            <a:off x="1218617" y="3412027"/>
            <a:ext cx="5400110" cy="27528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77CAB29-0728-52E3-7E7B-CA440F9E9BC4}"/>
                </a:ext>
              </a:extLst>
            </p:cNvPr>
            <p:cNvSpPr txBox="1"/>
            <p:nvPr/>
          </p:nvSpPr>
          <p:spPr>
            <a:xfrm>
              <a:off x="1217014" y="3483504"/>
              <a:ext cx="384499" cy="5559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5328989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27</TotalTime>
  <Words>35</Words>
  <Application>Microsoft Office PowerPoint</Application>
  <PresentationFormat>Widescreen</PresentationFormat>
  <Paragraphs>1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LVESTRI Frederic</dc:creator>
  <cp:lastModifiedBy>Abhishek Kumar</cp:lastModifiedBy>
  <cp:revision>6</cp:revision>
  <dcterms:created xsi:type="dcterms:W3CDTF">2024-08-29T15:12:47Z</dcterms:created>
  <dcterms:modified xsi:type="dcterms:W3CDTF">2025-06-02T08:03:44Z</dcterms:modified>
</cp:coreProperties>
</file>